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985000" cy="92837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 snapToGrid="0" showGuides="1">
      <p:cViewPr varScale="1">
        <p:scale>
          <a:sx n="111" d="100"/>
          <a:sy n="111" d="100"/>
        </p:scale>
        <p:origin x="-2502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92283D-F7D1-4E96-8232-2B577460C63D}" type="datetimeFigureOut">
              <a:rPr lang="de-DE" smtClean="0"/>
              <a:t>26.10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46FBD-CB54-4D2F-80ED-BF2ED82C4F1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807329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92283D-F7D1-4E96-8232-2B577460C63D}" type="datetimeFigureOut">
              <a:rPr lang="de-DE" smtClean="0"/>
              <a:t>26.10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46FBD-CB54-4D2F-80ED-BF2ED82C4F1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234319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92283D-F7D1-4E96-8232-2B577460C63D}" type="datetimeFigureOut">
              <a:rPr lang="de-DE" smtClean="0"/>
              <a:t>26.10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46FBD-CB54-4D2F-80ED-BF2ED82C4F1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874108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92283D-F7D1-4E96-8232-2B577460C63D}" type="datetimeFigureOut">
              <a:rPr lang="de-DE" smtClean="0"/>
              <a:t>26.10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46FBD-CB54-4D2F-80ED-BF2ED82C4F1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671409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92283D-F7D1-4E96-8232-2B577460C63D}" type="datetimeFigureOut">
              <a:rPr lang="de-DE" smtClean="0"/>
              <a:t>26.10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46FBD-CB54-4D2F-80ED-BF2ED82C4F1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614410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92283D-F7D1-4E96-8232-2B577460C63D}" type="datetimeFigureOut">
              <a:rPr lang="de-DE" smtClean="0"/>
              <a:t>26.10.201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46FBD-CB54-4D2F-80ED-BF2ED82C4F1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789248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92283D-F7D1-4E96-8232-2B577460C63D}" type="datetimeFigureOut">
              <a:rPr lang="de-DE" smtClean="0"/>
              <a:t>26.10.2015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46FBD-CB54-4D2F-80ED-BF2ED82C4F1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70377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92283D-F7D1-4E96-8232-2B577460C63D}" type="datetimeFigureOut">
              <a:rPr lang="de-DE" smtClean="0"/>
              <a:t>26.10.2015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46FBD-CB54-4D2F-80ED-BF2ED82C4F1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964002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92283D-F7D1-4E96-8232-2B577460C63D}" type="datetimeFigureOut">
              <a:rPr lang="de-DE" smtClean="0"/>
              <a:t>26.10.2015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46FBD-CB54-4D2F-80ED-BF2ED82C4F1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594930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92283D-F7D1-4E96-8232-2B577460C63D}" type="datetimeFigureOut">
              <a:rPr lang="de-DE" smtClean="0"/>
              <a:t>26.10.201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46FBD-CB54-4D2F-80ED-BF2ED82C4F1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540652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92283D-F7D1-4E96-8232-2B577460C63D}" type="datetimeFigureOut">
              <a:rPr lang="de-DE" smtClean="0"/>
              <a:t>26.10.201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46FBD-CB54-4D2F-80ED-BF2ED82C4F1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351347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92283D-F7D1-4E96-8232-2B577460C63D}" type="datetimeFigureOut">
              <a:rPr lang="de-DE" smtClean="0"/>
              <a:t>26.10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D46FBD-CB54-4D2F-80ED-BF2ED82C4F1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111623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7391400" y="152400"/>
            <a:ext cx="16850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ata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1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feld 4"/>
          <p:cNvSpPr txBox="1"/>
          <p:nvPr/>
        </p:nvSpPr>
        <p:spPr>
          <a:xfrm>
            <a:off x="937648" y="5080862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2057" name="Picture 9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42448" y="2102712"/>
            <a:ext cx="3538537" cy="30607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Rechteck 1"/>
          <p:cNvSpPr/>
          <p:nvPr/>
        </p:nvSpPr>
        <p:spPr>
          <a:xfrm>
            <a:off x="404248" y="5766662"/>
            <a:ext cx="8458200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marogentin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(A) 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zelastine (B)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how no cytotoxicity in LAD-2 cells in the concentration range used in the experiments. Cell viability was measured 24 h after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amarogentin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nd azelastine treatment. 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dirty="0"/>
              <a:t> </a:t>
            </a:r>
            <a:endParaRPr lang="de-DE" dirty="0"/>
          </a:p>
          <a:p>
            <a:endParaRPr lang="de-DE" dirty="0"/>
          </a:p>
        </p:txBody>
      </p:sp>
      <p:sp>
        <p:nvSpPr>
          <p:cNvPr id="7" name="Textfeld 6"/>
          <p:cNvSpPr txBox="1"/>
          <p:nvPr/>
        </p:nvSpPr>
        <p:spPr>
          <a:xfrm>
            <a:off x="5128648" y="5080862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2053" name="Picture 5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28648" y="2109062"/>
            <a:ext cx="3352800" cy="342509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Textfeld 2"/>
          <p:cNvSpPr txBox="1"/>
          <p:nvPr/>
        </p:nvSpPr>
        <p:spPr>
          <a:xfrm>
            <a:off x="957824" y="464948"/>
            <a:ext cx="6763390" cy="17543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ell viability of LAD-2 cells after </a:t>
            </a:r>
            <a:r>
              <a:rPr lang="en-US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marogentin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nd azelastine treatment</a:t>
            </a:r>
          </a:p>
          <a:p>
            <a:endParaRPr lang="en-US" sz="12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marogetin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(100 µM) and azelastine (24 µM) were used in not cytotoxic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oncentrations. </a:t>
            </a:r>
          </a:p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To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test the cytotoxicity of the extracts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LAD-2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ell viability was assessed with the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ViaLight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Plus ATP assay </a:t>
            </a:r>
            <a:endParaRPr lang="en-US" sz="11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Cambrex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, Verviers, Belgium) according to the manufacturer’s instruction.  The method is based on the </a:t>
            </a:r>
            <a:endParaRPr lang="en-US" sz="11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bioluminescent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measurement of ATP that is present in metabolically active cells. Luciferase catalyzes </a:t>
            </a:r>
            <a:endParaRPr lang="en-US" sz="11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formation of light from ATP and luciferin. The emitted light intensity is directly proportional to the </a:t>
            </a:r>
            <a:endParaRPr lang="en-US" sz="11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ATP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oncentration and is measured with a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luminometer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(Sirius HT, MWG). </a:t>
            </a:r>
            <a:endParaRPr lang="de-DE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197065473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152</Words>
  <Application>Microsoft Office PowerPoint</Application>
  <PresentationFormat>On-screen Show (4:3)</PresentationFormat>
  <Paragraphs>1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Larissa</vt:lpstr>
      <vt:lpstr>PowerPoint Presentation</vt:lpstr>
    </vt:vector>
  </TitlesOfParts>
  <Company>Uniklinikum Freiburg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r. Ute Wölfle</dc:creator>
  <cp:lastModifiedBy>staff</cp:lastModifiedBy>
  <cp:revision>10</cp:revision>
  <cp:lastPrinted>2015-10-26T09:43:56Z</cp:lastPrinted>
  <dcterms:created xsi:type="dcterms:W3CDTF">2015-10-07T09:17:01Z</dcterms:created>
  <dcterms:modified xsi:type="dcterms:W3CDTF">2015-10-26T09:50:11Z</dcterms:modified>
</cp:coreProperties>
</file>